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jl, gemiddeld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1" d="100"/>
          <a:sy n="111" d="100"/>
        </p:scale>
        <p:origin x="45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ienb\Dropbox\PME-BIM%20Labo\Post%20doc%20&amp;%20PDM\Eigen%20publicaties\Paper%208%20Hommels%20illumina\Paper%202%20populaties\Final\Indiening%20PLOS%20ONE\Supporting%20information%20Table%20S4%20-%20kopi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nl-N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3803200766154977E-2"/>
          <c:y val="9.0507818415504038E-2"/>
          <c:w val="0.88227515840922255"/>
          <c:h val="0.79278619883916213"/>
        </c:manualLayout>
      </c:layout>
      <c:barChart>
        <c:barDir val="bar"/>
        <c:grouping val="stacked"/>
        <c:varyColors val="0"/>
        <c:ser>
          <c:idx val="0"/>
          <c:order val="0"/>
          <c:tx>
            <c:strRef>
              <c:f>Blad1!$C$19</c:f>
              <c:strCache>
                <c:ptCount val="1"/>
                <c:pt idx="0">
                  <c:v>Trichoderma asperelloides (OTU1)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Blad1!$D$4:$K$4</c:f>
              <c:strCache>
                <c:ptCount val="8"/>
                <c:pt idx="0">
                  <c:v>S1_1</c:v>
                </c:pt>
                <c:pt idx="1">
                  <c:v>S1_2</c:v>
                </c:pt>
                <c:pt idx="2">
                  <c:v>S1_3</c:v>
                </c:pt>
                <c:pt idx="3">
                  <c:v>S1_4</c:v>
                </c:pt>
                <c:pt idx="4">
                  <c:v>S1_5</c:v>
                </c:pt>
                <c:pt idx="5">
                  <c:v>S1_6</c:v>
                </c:pt>
                <c:pt idx="6">
                  <c:v>S1_7</c:v>
                </c:pt>
                <c:pt idx="7">
                  <c:v>S1_8</c:v>
                </c:pt>
              </c:strCache>
            </c:strRef>
          </c:cat>
          <c:val>
            <c:numRef>
              <c:f>Blad1!$D$19:$K$19</c:f>
              <c:numCache>
                <c:formatCode>0.000</c:formatCode>
                <c:ptCount val="8"/>
                <c:pt idx="0">
                  <c:v>0</c:v>
                </c:pt>
                <c:pt idx="1">
                  <c:v>5.0150451354062188E-2</c:v>
                </c:pt>
                <c:pt idx="2">
                  <c:v>52.808425275827489</c:v>
                </c:pt>
                <c:pt idx="3">
                  <c:v>1.5045135406218655</c:v>
                </c:pt>
                <c:pt idx="4">
                  <c:v>0.4012036108324975</c:v>
                </c:pt>
                <c:pt idx="5">
                  <c:v>7.9237713139418258</c:v>
                </c:pt>
                <c:pt idx="6">
                  <c:v>0.15045135406218654</c:v>
                </c:pt>
                <c:pt idx="7">
                  <c:v>0.752256770310932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AAE-408E-B3F2-3B694876C91B}"/>
            </c:ext>
          </c:extLst>
        </c:ser>
        <c:ser>
          <c:idx val="1"/>
          <c:order val="1"/>
          <c:tx>
            <c:strRef>
              <c:f>Blad1!$C$20</c:f>
              <c:strCache>
                <c:ptCount val="1"/>
                <c:pt idx="0">
                  <c:v>Saccharomyces kudriavzevii (OTU2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Blad1!$D$4:$K$4</c:f>
              <c:strCache>
                <c:ptCount val="8"/>
                <c:pt idx="0">
                  <c:v>S1_1</c:v>
                </c:pt>
                <c:pt idx="1">
                  <c:v>S1_2</c:v>
                </c:pt>
                <c:pt idx="2">
                  <c:v>S1_3</c:v>
                </c:pt>
                <c:pt idx="3">
                  <c:v>S1_4</c:v>
                </c:pt>
                <c:pt idx="4">
                  <c:v>S1_5</c:v>
                </c:pt>
                <c:pt idx="5">
                  <c:v>S1_6</c:v>
                </c:pt>
                <c:pt idx="6">
                  <c:v>S1_7</c:v>
                </c:pt>
                <c:pt idx="7">
                  <c:v>S1_8</c:v>
                </c:pt>
              </c:strCache>
            </c:strRef>
          </c:cat>
          <c:val>
            <c:numRef>
              <c:f>Blad1!$D$20:$K$20</c:f>
              <c:numCache>
                <c:formatCode>0.000</c:formatCode>
                <c:ptCount val="8"/>
                <c:pt idx="0">
                  <c:v>15.897693079237712</c:v>
                </c:pt>
                <c:pt idx="1">
                  <c:v>28.635907723169506</c:v>
                </c:pt>
                <c:pt idx="2">
                  <c:v>30.391173520561686</c:v>
                </c:pt>
                <c:pt idx="3">
                  <c:v>14.242728184553661</c:v>
                </c:pt>
                <c:pt idx="4">
                  <c:v>2.3069207622868606</c:v>
                </c:pt>
                <c:pt idx="5">
                  <c:v>62.938816449348046</c:v>
                </c:pt>
                <c:pt idx="6">
                  <c:v>3.9117352056168508</c:v>
                </c:pt>
                <c:pt idx="7">
                  <c:v>19.7091273821464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AAE-408E-B3F2-3B694876C91B}"/>
            </c:ext>
          </c:extLst>
        </c:ser>
        <c:ser>
          <c:idx val="2"/>
          <c:order val="2"/>
          <c:tx>
            <c:strRef>
              <c:f>Blad1!$C$21</c:f>
              <c:strCache>
                <c:ptCount val="1"/>
                <c:pt idx="0">
                  <c:v>Mucor ellipsoideus (OTU4)</c:v>
                </c:pt>
              </c:strCache>
            </c:strRef>
          </c:tx>
          <c:spPr>
            <a:solidFill>
              <a:schemeClr val="accent4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D$4:$K$4</c:f>
              <c:strCache>
                <c:ptCount val="8"/>
                <c:pt idx="0">
                  <c:v>S1_1</c:v>
                </c:pt>
                <c:pt idx="1">
                  <c:v>S1_2</c:v>
                </c:pt>
                <c:pt idx="2">
                  <c:v>S1_3</c:v>
                </c:pt>
                <c:pt idx="3">
                  <c:v>S1_4</c:v>
                </c:pt>
                <c:pt idx="4">
                  <c:v>S1_5</c:v>
                </c:pt>
                <c:pt idx="5">
                  <c:v>S1_6</c:v>
                </c:pt>
                <c:pt idx="6">
                  <c:v>S1_7</c:v>
                </c:pt>
                <c:pt idx="7">
                  <c:v>S1_8</c:v>
                </c:pt>
              </c:strCache>
            </c:strRef>
          </c:cat>
          <c:val>
            <c:numRef>
              <c:f>Blad1!$D$21:$K$21</c:f>
              <c:numCache>
                <c:formatCode>0.000</c:formatCode>
                <c:ptCount val="8"/>
                <c:pt idx="0">
                  <c:v>5.6168505516549647</c:v>
                </c:pt>
                <c:pt idx="1">
                  <c:v>44.282848545636909</c:v>
                </c:pt>
                <c:pt idx="2">
                  <c:v>0.95285857572718158</c:v>
                </c:pt>
                <c:pt idx="3">
                  <c:v>0.60180541624874617</c:v>
                </c:pt>
                <c:pt idx="4">
                  <c:v>87.963891675025081</c:v>
                </c:pt>
                <c:pt idx="5">
                  <c:v>0.85255767301905716</c:v>
                </c:pt>
                <c:pt idx="6">
                  <c:v>0</c:v>
                </c:pt>
                <c:pt idx="7">
                  <c:v>11.8856569709127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AAE-408E-B3F2-3B694876C91B}"/>
            </c:ext>
          </c:extLst>
        </c:ser>
        <c:ser>
          <c:idx val="3"/>
          <c:order val="3"/>
          <c:tx>
            <c:strRef>
              <c:f>Blad1!$C$22</c:f>
              <c:strCache>
                <c:ptCount val="1"/>
                <c:pt idx="0">
                  <c:v>Phaeolus schweinitzii (OTU5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Blad1!$D$4:$K$4</c:f>
              <c:strCache>
                <c:ptCount val="8"/>
                <c:pt idx="0">
                  <c:v>S1_1</c:v>
                </c:pt>
                <c:pt idx="1">
                  <c:v>S1_2</c:v>
                </c:pt>
                <c:pt idx="2">
                  <c:v>S1_3</c:v>
                </c:pt>
                <c:pt idx="3">
                  <c:v>S1_4</c:v>
                </c:pt>
                <c:pt idx="4">
                  <c:v>S1_5</c:v>
                </c:pt>
                <c:pt idx="5">
                  <c:v>S1_6</c:v>
                </c:pt>
                <c:pt idx="6">
                  <c:v>S1_7</c:v>
                </c:pt>
                <c:pt idx="7">
                  <c:v>S1_8</c:v>
                </c:pt>
              </c:strCache>
            </c:strRef>
          </c:cat>
          <c:val>
            <c:numRef>
              <c:f>Blad1!$D$22:$K$22</c:f>
              <c:numCache>
                <c:formatCode>0.000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AAE-408E-B3F2-3B694876C91B}"/>
            </c:ext>
          </c:extLst>
        </c:ser>
        <c:ser>
          <c:idx val="4"/>
          <c:order val="4"/>
          <c:tx>
            <c:strRef>
              <c:f>Blad1!$C$23</c:f>
              <c:strCache>
                <c:ptCount val="1"/>
                <c:pt idx="0">
                  <c:v>Tuber regianum (OTU6)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Blad1!$D$4:$K$4</c:f>
              <c:strCache>
                <c:ptCount val="8"/>
                <c:pt idx="0">
                  <c:v>S1_1</c:v>
                </c:pt>
                <c:pt idx="1">
                  <c:v>S1_2</c:v>
                </c:pt>
                <c:pt idx="2">
                  <c:v>S1_3</c:v>
                </c:pt>
                <c:pt idx="3">
                  <c:v>S1_4</c:v>
                </c:pt>
                <c:pt idx="4">
                  <c:v>S1_5</c:v>
                </c:pt>
                <c:pt idx="5">
                  <c:v>S1_6</c:v>
                </c:pt>
                <c:pt idx="6">
                  <c:v>S1_7</c:v>
                </c:pt>
                <c:pt idx="7">
                  <c:v>S1_8</c:v>
                </c:pt>
              </c:strCache>
            </c:strRef>
          </c:cat>
          <c:val>
            <c:numRef>
              <c:f>Blad1!$D$23:$K$23</c:f>
              <c:numCache>
                <c:formatCode>0.000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AAE-408E-B3F2-3B694876C91B}"/>
            </c:ext>
          </c:extLst>
        </c:ser>
        <c:ser>
          <c:idx val="5"/>
          <c:order val="5"/>
          <c:tx>
            <c:strRef>
              <c:f>Blad1!$C$24</c:f>
              <c:strCache>
                <c:ptCount val="1"/>
                <c:pt idx="0">
                  <c:v>Leccinum rndifoliae (OTU7)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Blad1!$D$4:$K$4</c:f>
              <c:strCache>
                <c:ptCount val="8"/>
                <c:pt idx="0">
                  <c:v>S1_1</c:v>
                </c:pt>
                <c:pt idx="1">
                  <c:v>S1_2</c:v>
                </c:pt>
                <c:pt idx="2">
                  <c:v>S1_3</c:v>
                </c:pt>
                <c:pt idx="3">
                  <c:v>S1_4</c:v>
                </c:pt>
                <c:pt idx="4">
                  <c:v>S1_5</c:v>
                </c:pt>
                <c:pt idx="5">
                  <c:v>S1_6</c:v>
                </c:pt>
                <c:pt idx="6">
                  <c:v>S1_7</c:v>
                </c:pt>
                <c:pt idx="7">
                  <c:v>S1_8</c:v>
                </c:pt>
              </c:strCache>
            </c:strRef>
          </c:cat>
          <c:val>
            <c:numRef>
              <c:f>Blad1!$D$24:$K$24</c:f>
              <c:numCache>
                <c:formatCode>0.000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58.3751253761283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7AAE-408E-B3F2-3B694876C91B}"/>
            </c:ext>
          </c:extLst>
        </c:ser>
        <c:ser>
          <c:idx val="6"/>
          <c:order val="6"/>
          <c:tx>
            <c:strRef>
              <c:f>Blad1!$C$25</c:f>
              <c:strCache>
                <c:ptCount val="1"/>
                <c:pt idx="0">
                  <c:v>Penicillium dipodomyis (OTU8)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D$4:$K$4</c:f>
              <c:strCache>
                <c:ptCount val="8"/>
                <c:pt idx="0">
                  <c:v>S1_1</c:v>
                </c:pt>
                <c:pt idx="1">
                  <c:v>S1_2</c:v>
                </c:pt>
                <c:pt idx="2">
                  <c:v>S1_3</c:v>
                </c:pt>
                <c:pt idx="3">
                  <c:v>S1_4</c:v>
                </c:pt>
                <c:pt idx="4">
                  <c:v>S1_5</c:v>
                </c:pt>
                <c:pt idx="5">
                  <c:v>S1_6</c:v>
                </c:pt>
                <c:pt idx="6">
                  <c:v>S1_7</c:v>
                </c:pt>
                <c:pt idx="7">
                  <c:v>S1_8</c:v>
                </c:pt>
              </c:strCache>
            </c:strRef>
          </c:cat>
          <c:val>
            <c:numRef>
              <c:f>Blad1!$D$25:$K$25</c:f>
              <c:numCache>
                <c:formatCode>0.000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38.214643931795386</c:v>
                </c:pt>
                <c:pt idx="4">
                  <c:v>0</c:v>
                </c:pt>
                <c:pt idx="5">
                  <c:v>0</c:v>
                </c:pt>
                <c:pt idx="6">
                  <c:v>0.15045135406218654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7AAE-408E-B3F2-3B694876C91B}"/>
            </c:ext>
          </c:extLst>
        </c:ser>
        <c:ser>
          <c:idx val="7"/>
          <c:order val="7"/>
          <c:tx>
            <c:strRef>
              <c:f>Blad1!$C$26</c:f>
              <c:strCache>
                <c:ptCount val="1"/>
                <c:pt idx="0">
                  <c:v>Lactariusfumosibrunneus (OTU11)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D$4:$K$4</c:f>
              <c:strCache>
                <c:ptCount val="8"/>
                <c:pt idx="0">
                  <c:v>S1_1</c:v>
                </c:pt>
                <c:pt idx="1">
                  <c:v>S1_2</c:v>
                </c:pt>
                <c:pt idx="2">
                  <c:v>S1_3</c:v>
                </c:pt>
                <c:pt idx="3">
                  <c:v>S1_4</c:v>
                </c:pt>
                <c:pt idx="4">
                  <c:v>S1_5</c:v>
                </c:pt>
                <c:pt idx="5">
                  <c:v>S1_6</c:v>
                </c:pt>
                <c:pt idx="6">
                  <c:v>S1_7</c:v>
                </c:pt>
                <c:pt idx="7">
                  <c:v>S1_8</c:v>
                </c:pt>
              </c:strCache>
            </c:strRef>
          </c:cat>
          <c:val>
            <c:numRef>
              <c:f>Blad1!$D$26:$K$26</c:f>
              <c:numCache>
                <c:formatCode>0.000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39.819458375125379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7AAE-408E-B3F2-3B694876C91B}"/>
            </c:ext>
          </c:extLst>
        </c:ser>
        <c:ser>
          <c:idx val="8"/>
          <c:order val="8"/>
          <c:tx>
            <c:strRef>
              <c:f>Blad1!$C$27</c:f>
              <c:strCache>
                <c:ptCount val="1"/>
                <c:pt idx="0">
                  <c:v>Lactifluus sp. (OTU14)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D$4:$K$4</c:f>
              <c:strCache>
                <c:ptCount val="8"/>
                <c:pt idx="0">
                  <c:v>S1_1</c:v>
                </c:pt>
                <c:pt idx="1">
                  <c:v>S1_2</c:v>
                </c:pt>
                <c:pt idx="2">
                  <c:v>S1_3</c:v>
                </c:pt>
                <c:pt idx="3">
                  <c:v>S1_4</c:v>
                </c:pt>
                <c:pt idx="4">
                  <c:v>S1_5</c:v>
                </c:pt>
                <c:pt idx="5">
                  <c:v>S1_6</c:v>
                </c:pt>
                <c:pt idx="6">
                  <c:v>S1_7</c:v>
                </c:pt>
                <c:pt idx="7">
                  <c:v>S1_8</c:v>
                </c:pt>
              </c:strCache>
            </c:strRef>
          </c:cat>
          <c:val>
            <c:numRef>
              <c:f>Blad1!$D$27:$K$27</c:f>
              <c:numCache>
                <c:formatCode>0.000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7AAE-408E-B3F2-3B694876C91B}"/>
            </c:ext>
          </c:extLst>
        </c:ser>
        <c:ser>
          <c:idx val="9"/>
          <c:order val="9"/>
          <c:tx>
            <c:strRef>
              <c:f>Blad1!$C$28</c:f>
              <c:strCache>
                <c:ptCount val="1"/>
                <c:pt idx="0">
                  <c:v>Plectosphaerella plurivora (OTU18)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D$4:$K$4</c:f>
              <c:strCache>
                <c:ptCount val="8"/>
                <c:pt idx="0">
                  <c:v>S1_1</c:v>
                </c:pt>
                <c:pt idx="1">
                  <c:v>S1_2</c:v>
                </c:pt>
                <c:pt idx="2">
                  <c:v>S1_3</c:v>
                </c:pt>
                <c:pt idx="3">
                  <c:v>S1_4</c:v>
                </c:pt>
                <c:pt idx="4">
                  <c:v>S1_5</c:v>
                </c:pt>
                <c:pt idx="5">
                  <c:v>S1_6</c:v>
                </c:pt>
                <c:pt idx="6">
                  <c:v>S1_7</c:v>
                </c:pt>
                <c:pt idx="7">
                  <c:v>S1_8</c:v>
                </c:pt>
              </c:strCache>
            </c:strRef>
          </c:cat>
          <c:val>
            <c:numRef>
              <c:f>Blad1!$D$28:$K$28</c:f>
              <c:numCache>
                <c:formatCode>0.000</c:formatCode>
                <c:ptCount val="8"/>
                <c:pt idx="0">
                  <c:v>3.4603811434302911</c:v>
                </c:pt>
                <c:pt idx="1">
                  <c:v>2.7582748244734203</c:v>
                </c:pt>
                <c:pt idx="2">
                  <c:v>0</c:v>
                </c:pt>
                <c:pt idx="3">
                  <c:v>0.80240722166499501</c:v>
                </c:pt>
                <c:pt idx="4">
                  <c:v>0</c:v>
                </c:pt>
                <c:pt idx="5">
                  <c:v>12.688064192577734</c:v>
                </c:pt>
                <c:pt idx="6">
                  <c:v>0</c:v>
                </c:pt>
                <c:pt idx="7">
                  <c:v>0.250752256770310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7AAE-408E-B3F2-3B694876C91B}"/>
            </c:ext>
          </c:extLst>
        </c:ser>
        <c:ser>
          <c:idx val="10"/>
          <c:order val="10"/>
          <c:tx>
            <c:strRef>
              <c:f>Blad1!$C$29</c:f>
              <c:strCache>
                <c:ptCount val="1"/>
                <c:pt idx="0">
                  <c:v>Wickerhamomyces ciferrii (OTU35)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D$4:$K$4</c:f>
              <c:strCache>
                <c:ptCount val="8"/>
                <c:pt idx="0">
                  <c:v>S1_1</c:v>
                </c:pt>
                <c:pt idx="1">
                  <c:v>S1_2</c:v>
                </c:pt>
                <c:pt idx="2">
                  <c:v>S1_3</c:v>
                </c:pt>
                <c:pt idx="3">
                  <c:v>S1_4</c:v>
                </c:pt>
                <c:pt idx="4">
                  <c:v>S1_5</c:v>
                </c:pt>
                <c:pt idx="5">
                  <c:v>S1_6</c:v>
                </c:pt>
                <c:pt idx="6">
                  <c:v>S1_7</c:v>
                </c:pt>
                <c:pt idx="7">
                  <c:v>S1_8</c:v>
                </c:pt>
              </c:strCache>
            </c:strRef>
          </c:cat>
          <c:val>
            <c:numRef>
              <c:f>Blad1!$D$29:$K$29</c:f>
              <c:numCache>
                <c:formatCode>0.000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7AAE-408E-B3F2-3B694876C91B}"/>
            </c:ext>
          </c:extLst>
        </c:ser>
        <c:ser>
          <c:idx val="11"/>
          <c:order val="11"/>
          <c:tx>
            <c:strRef>
              <c:f>Blad1!$C$30</c:f>
              <c:strCache>
                <c:ptCount val="1"/>
                <c:pt idx="0">
                  <c:v>Hypocrea lixii (OTU120)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D$4:$K$4</c:f>
              <c:strCache>
                <c:ptCount val="8"/>
                <c:pt idx="0">
                  <c:v>S1_1</c:v>
                </c:pt>
                <c:pt idx="1">
                  <c:v>S1_2</c:v>
                </c:pt>
                <c:pt idx="2">
                  <c:v>S1_3</c:v>
                </c:pt>
                <c:pt idx="3">
                  <c:v>S1_4</c:v>
                </c:pt>
                <c:pt idx="4">
                  <c:v>S1_5</c:v>
                </c:pt>
                <c:pt idx="5">
                  <c:v>S1_6</c:v>
                </c:pt>
                <c:pt idx="6">
                  <c:v>S1_7</c:v>
                </c:pt>
                <c:pt idx="7">
                  <c:v>S1_8</c:v>
                </c:pt>
              </c:strCache>
            </c:strRef>
          </c:cat>
          <c:val>
            <c:numRef>
              <c:f>Blad1!$D$30:$K$30</c:f>
              <c:numCache>
                <c:formatCode>0.000</c:formatCode>
                <c:ptCount val="8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51.955867602808425</c:v>
                </c:pt>
                <c:pt idx="7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7AAE-408E-B3F2-3B694876C9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483396880"/>
        <c:axId val="483402784"/>
      </c:barChart>
      <c:catAx>
        <c:axId val="48339688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483402784"/>
        <c:crosses val="autoZero"/>
        <c:auto val="1"/>
        <c:lblAlgn val="ctr"/>
        <c:lblOffset val="100"/>
        <c:noMultiLvlLbl val="0"/>
      </c:catAx>
      <c:valAx>
        <c:axId val="483402784"/>
        <c:scaling>
          <c:orientation val="minMax"/>
          <c:max val="100"/>
        </c:scaling>
        <c:delete val="0"/>
        <c:axPos val="b"/>
        <c:numFmt formatCode="0.000" sourceLinked="1"/>
        <c:majorTickMark val="in"/>
        <c:minorTickMark val="in"/>
        <c:tickLblPos val="nextTo"/>
        <c:spPr>
          <a:noFill/>
          <a:ln>
            <a:solidFill>
              <a:schemeClr val="accent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483396880"/>
        <c:crosses val="autoZero"/>
        <c:crossBetween val="between"/>
      </c:valAx>
      <c:spPr>
        <a:solidFill>
          <a:schemeClr val="bg1"/>
        </a:solidFill>
        <a:ln>
          <a:solidFill>
            <a:schemeClr val="bg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NL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nl-N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stacked"/>
        <c:varyColors val="0"/>
        <c:ser>
          <c:idx val="0"/>
          <c:order val="0"/>
          <c:tx>
            <c:strRef>
              <c:f>Blad1!$C$19</c:f>
              <c:strCache>
                <c:ptCount val="1"/>
                <c:pt idx="0">
                  <c:v>Trichoderma asperelloides (OTU1)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Blad1!$N$4:$W$4</c:f>
              <c:strCache>
                <c:ptCount val="10"/>
                <c:pt idx="0">
                  <c:v>S2_1</c:v>
                </c:pt>
                <c:pt idx="1">
                  <c:v>S2_2</c:v>
                </c:pt>
                <c:pt idx="2">
                  <c:v>S2_3</c:v>
                </c:pt>
                <c:pt idx="3">
                  <c:v>S2_4</c:v>
                </c:pt>
                <c:pt idx="4">
                  <c:v>S2_5</c:v>
                </c:pt>
                <c:pt idx="5">
                  <c:v>S2_6</c:v>
                </c:pt>
                <c:pt idx="6">
                  <c:v>S2_7</c:v>
                </c:pt>
                <c:pt idx="7">
                  <c:v>S2_8</c:v>
                </c:pt>
                <c:pt idx="8">
                  <c:v>S2_9</c:v>
                </c:pt>
                <c:pt idx="9">
                  <c:v>S2_10</c:v>
                </c:pt>
              </c:strCache>
            </c:strRef>
          </c:cat>
          <c:val>
            <c:numRef>
              <c:f>Blad1!$N$19:$W$19</c:f>
              <c:numCache>
                <c:formatCode>0.000</c:formatCode>
                <c:ptCount val="10"/>
                <c:pt idx="0">
                  <c:v>74.37311935807422</c:v>
                </c:pt>
                <c:pt idx="1">
                  <c:v>0.75225677031093274</c:v>
                </c:pt>
                <c:pt idx="2">
                  <c:v>66.499498495486463</c:v>
                </c:pt>
                <c:pt idx="3">
                  <c:v>13.28986960882648</c:v>
                </c:pt>
                <c:pt idx="4">
                  <c:v>16.49949849548646</c:v>
                </c:pt>
                <c:pt idx="5">
                  <c:v>1.4543630892678034</c:v>
                </c:pt>
                <c:pt idx="6">
                  <c:v>6.0180541624874619</c:v>
                </c:pt>
                <c:pt idx="7">
                  <c:v>0.10030090270812438</c:v>
                </c:pt>
                <c:pt idx="8">
                  <c:v>7.3219658976930795</c:v>
                </c:pt>
                <c:pt idx="9">
                  <c:v>17.452357071213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792-4B74-AFC7-D0179422A083}"/>
            </c:ext>
          </c:extLst>
        </c:ser>
        <c:ser>
          <c:idx val="1"/>
          <c:order val="1"/>
          <c:tx>
            <c:strRef>
              <c:f>Blad1!$C$20</c:f>
              <c:strCache>
                <c:ptCount val="1"/>
                <c:pt idx="0">
                  <c:v>Saccharomyces kudriavzevii (OTU2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Blad1!$N$4:$W$4</c:f>
              <c:strCache>
                <c:ptCount val="10"/>
                <c:pt idx="0">
                  <c:v>S2_1</c:v>
                </c:pt>
                <c:pt idx="1">
                  <c:v>S2_2</c:v>
                </c:pt>
                <c:pt idx="2">
                  <c:v>S2_3</c:v>
                </c:pt>
                <c:pt idx="3">
                  <c:v>S2_4</c:v>
                </c:pt>
                <c:pt idx="4">
                  <c:v>S2_5</c:v>
                </c:pt>
                <c:pt idx="5">
                  <c:v>S2_6</c:v>
                </c:pt>
                <c:pt idx="6">
                  <c:v>S2_7</c:v>
                </c:pt>
                <c:pt idx="7">
                  <c:v>S2_8</c:v>
                </c:pt>
                <c:pt idx="8">
                  <c:v>S2_9</c:v>
                </c:pt>
                <c:pt idx="9">
                  <c:v>S2_10</c:v>
                </c:pt>
              </c:strCache>
            </c:strRef>
          </c:cat>
          <c:val>
            <c:numRef>
              <c:f>Blad1!$N$20:$W$20</c:f>
              <c:numCache>
                <c:formatCode>0.000</c:formatCode>
                <c:ptCount val="10"/>
                <c:pt idx="0">
                  <c:v>8.224674022066198</c:v>
                </c:pt>
                <c:pt idx="1">
                  <c:v>93.58074222668003</c:v>
                </c:pt>
                <c:pt idx="2">
                  <c:v>28.134403209628889</c:v>
                </c:pt>
                <c:pt idx="3">
                  <c:v>59.929789368104316</c:v>
                </c:pt>
                <c:pt idx="4">
                  <c:v>74.674022066198603</c:v>
                </c:pt>
                <c:pt idx="5">
                  <c:v>35.305917753259777</c:v>
                </c:pt>
                <c:pt idx="6">
                  <c:v>49.047141424272816</c:v>
                </c:pt>
                <c:pt idx="7">
                  <c:v>4.5135406218655971</c:v>
                </c:pt>
                <c:pt idx="8">
                  <c:v>55.967903711133403</c:v>
                </c:pt>
                <c:pt idx="9">
                  <c:v>5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792-4B74-AFC7-D0179422A083}"/>
            </c:ext>
          </c:extLst>
        </c:ser>
        <c:ser>
          <c:idx val="2"/>
          <c:order val="2"/>
          <c:tx>
            <c:strRef>
              <c:f>Blad1!$C$21</c:f>
              <c:strCache>
                <c:ptCount val="1"/>
                <c:pt idx="0">
                  <c:v>Mucor ellipsoideus (OTU4)</c:v>
                </c:pt>
              </c:strCache>
            </c:strRef>
          </c:tx>
          <c:spPr>
            <a:solidFill>
              <a:schemeClr val="accent4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N$4:$W$4</c:f>
              <c:strCache>
                <c:ptCount val="10"/>
                <c:pt idx="0">
                  <c:v>S2_1</c:v>
                </c:pt>
                <c:pt idx="1">
                  <c:v>S2_2</c:v>
                </c:pt>
                <c:pt idx="2">
                  <c:v>S2_3</c:v>
                </c:pt>
                <c:pt idx="3">
                  <c:v>S2_4</c:v>
                </c:pt>
                <c:pt idx="4">
                  <c:v>S2_5</c:v>
                </c:pt>
                <c:pt idx="5">
                  <c:v>S2_6</c:v>
                </c:pt>
                <c:pt idx="6">
                  <c:v>S2_7</c:v>
                </c:pt>
                <c:pt idx="7">
                  <c:v>S2_8</c:v>
                </c:pt>
                <c:pt idx="8">
                  <c:v>S2_9</c:v>
                </c:pt>
                <c:pt idx="9">
                  <c:v>S2_10</c:v>
                </c:pt>
              </c:strCache>
            </c:strRef>
          </c:cat>
          <c:val>
            <c:numRef>
              <c:f>Blad1!$N$21:$W$21</c:f>
              <c:numCache>
                <c:formatCode>0.000</c:formatCode>
                <c:ptCount val="10"/>
                <c:pt idx="0">
                  <c:v>1.5546639919759278</c:v>
                </c:pt>
                <c:pt idx="1">
                  <c:v>0</c:v>
                </c:pt>
                <c:pt idx="2">
                  <c:v>1.5546639919759278</c:v>
                </c:pt>
                <c:pt idx="3">
                  <c:v>1.1534603811434303</c:v>
                </c:pt>
                <c:pt idx="4">
                  <c:v>0.25075225677031093</c:v>
                </c:pt>
                <c:pt idx="5">
                  <c:v>3.9117352056168508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4.71414242728184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792-4B74-AFC7-D0179422A083}"/>
            </c:ext>
          </c:extLst>
        </c:ser>
        <c:ser>
          <c:idx val="3"/>
          <c:order val="3"/>
          <c:tx>
            <c:strRef>
              <c:f>Blad1!$C$22</c:f>
              <c:strCache>
                <c:ptCount val="1"/>
                <c:pt idx="0">
                  <c:v>Phaeolus schweinitzii (OTU5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Blad1!$N$4:$W$4</c:f>
              <c:strCache>
                <c:ptCount val="10"/>
                <c:pt idx="0">
                  <c:v>S2_1</c:v>
                </c:pt>
                <c:pt idx="1">
                  <c:v>S2_2</c:v>
                </c:pt>
                <c:pt idx="2">
                  <c:v>S2_3</c:v>
                </c:pt>
                <c:pt idx="3">
                  <c:v>S2_4</c:v>
                </c:pt>
                <c:pt idx="4">
                  <c:v>S2_5</c:v>
                </c:pt>
                <c:pt idx="5">
                  <c:v>S2_6</c:v>
                </c:pt>
                <c:pt idx="6">
                  <c:v>S2_7</c:v>
                </c:pt>
                <c:pt idx="7">
                  <c:v>S2_8</c:v>
                </c:pt>
                <c:pt idx="8">
                  <c:v>S2_9</c:v>
                </c:pt>
                <c:pt idx="9">
                  <c:v>S2_10</c:v>
                </c:pt>
              </c:strCache>
            </c:strRef>
          </c:cat>
          <c:val>
            <c:numRef>
              <c:f>Blad1!$N$22:$W$22</c:f>
              <c:numCache>
                <c:formatCode>0.000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5.9177532597793379</c:v>
                </c:pt>
                <c:pt idx="6">
                  <c:v>0</c:v>
                </c:pt>
                <c:pt idx="7">
                  <c:v>91.023069207622868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792-4B74-AFC7-D0179422A083}"/>
            </c:ext>
          </c:extLst>
        </c:ser>
        <c:ser>
          <c:idx val="4"/>
          <c:order val="4"/>
          <c:tx>
            <c:strRef>
              <c:f>Blad1!$C$23</c:f>
              <c:strCache>
                <c:ptCount val="1"/>
                <c:pt idx="0">
                  <c:v>Tuber regianum (OTU6)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Blad1!$N$4:$W$4</c:f>
              <c:strCache>
                <c:ptCount val="10"/>
                <c:pt idx="0">
                  <c:v>S2_1</c:v>
                </c:pt>
                <c:pt idx="1">
                  <c:v>S2_2</c:v>
                </c:pt>
                <c:pt idx="2">
                  <c:v>S2_3</c:v>
                </c:pt>
                <c:pt idx="3">
                  <c:v>S2_4</c:v>
                </c:pt>
                <c:pt idx="4">
                  <c:v>S2_5</c:v>
                </c:pt>
                <c:pt idx="5">
                  <c:v>S2_6</c:v>
                </c:pt>
                <c:pt idx="6">
                  <c:v>S2_7</c:v>
                </c:pt>
                <c:pt idx="7">
                  <c:v>S2_8</c:v>
                </c:pt>
                <c:pt idx="8">
                  <c:v>S2_9</c:v>
                </c:pt>
                <c:pt idx="9">
                  <c:v>S2_10</c:v>
                </c:pt>
              </c:strCache>
            </c:strRef>
          </c:cat>
          <c:val>
            <c:numRef>
              <c:f>Blad1!$N$23:$W$23</c:f>
              <c:numCache>
                <c:formatCode>0.000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A792-4B74-AFC7-D0179422A083}"/>
            </c:ext>
          </c:extLst>
        </c:ser>
        <c:ser>
          <c:idx val="5"/>
          <c:order val="5"/>
          <c:tx>
            <c:strRef>
              <c:f>Blad1!$C$24</c:f>
              <c:strCache>
                <c:ptCount val="1"/>
                <c:pt idx="0">
                  <c:v>Leccinum rndifoliae (OTU7)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Blad1!$N$4:$W$4</c:f>
              <c:strCache>
                <c:ptCount val="10"/>
                <c:pt idx="0">
                  <c:v>S2_1</c:v>
                </c:pt>
                <c:pt idx="1">
                  <c:v>S2_2</c:v>
                </c:pt>
                <c:pt idx="2">
                  <c:v>S2_3</c:v>
                </c:pt>
                <c:pt idx="3">
                  <c:v>S2_4</c:v>
                </c:pt>
                <c:pt idx="4">
                  <c:v>S2_5</c:v>
                </c:pt>
                <c:pt idx="5">
                  <c:v>S2_6</c:v>
                </c:pt>
                <c:pt idx="6">
                  <c:v>S2_7</c:v>
                </c:pt>
                <c:pt idx="7">
                  <c:v>S2_8</c:v>
                </c:pt>
                <c:pt idx="8">
                  <c:v>S2_9</c:v>
                </c:pt>
                <c:pt idx="9">
                  <c:v>S2_10</c:v>
                </c:pt>
              </c:strCache>
            </c:strRef>
          </c:cat>
          <c:val>
            <c:numRef>
              <c:f>Blad1!$N$24:$W$24</c:f>
              <c:numCache>
                <c:formatCode>0.000</c:formatCode>
                <c:ptCount val="10"/>
                <c:pt idx="0">
                  <c:v>1.2036108324974923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A792-4B74-AFC7-D0179422A083}"/>
            </c:ext>
          </c:extLst>
        </c:ser>
        <c:ser>
          <c:idx val="6"/>
          <c:order val="6"/>
          <c:tx>
            <c:strRef>
              <c:f>Blad1!$C$25</c:f>
              <c:strCache>
                <c:ptCount val="1"/>
                <c:pt idx="0">
                  <c:v>Penicillium dipodomyis (OTU8)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N$4:$W$4</c:f>
              <c:strCache>
                <c:ptCount val="10"/>
                <c:pt idx="0">
                  <c:v>S2_1</c:v>
                </c:pt>
                <c:pt idx="1">
                  <c:v>S2_2</c:v>
                </c:pt>
                <c:pt idx="2">
                  <c:v>S2_3</c:v>
                </c:pt>
                <c:pt idx="3">
                  <c:v>S2_4</c:v>
                </c:pt>
                <c:pt idx="4">
                  <c:v>S2_5</c:v>
                </c:pt>
                <c:pt idx="5">
                  <c:v>S2_6</c:v>
                </c:pt>
                <c:pt idx="6">
                  <c:v>S2_7</c:v>
                </c:pt>
                <c:pt idx="7">
                  <c:v>S2_8</c:v>
                </c:pt>
                <c:pt idx="8">
                  <c:v>S2_9</c:v>
                </c:pt>
                <c:pt idx="9">
                  <c:v>S2_10</c:v>
                </c:pt>
              </c:strCache>
            </c:strRef>
          </c:cat>
          <c:val>
            <c:numRef>
              <c:f>Blad1!$N$25:$W$25</c:f>
              <c:numCache>
                <c:formatCode>0.000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.10030090270812438</c:v>
                </c:pt>
                <c:pt idx="8">
                  <c:v>1.5045135406218655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A792-4B74-AFC7-D0179422A083}"/>
            </c:ext>
          </c:extLst>
        </c:ser>
        <c:ser>
          <c:idx val="7"/>
          <c:order val="7"/>
          <c:tx>
            <c:strRef>
              <c:f>Blad1!$C$26</c:f>
              <c:strCache>
                <c:ptCount val="1"/>
                <c:pt idx="0">
                  <c:v>Lactariusfumosibrunneus (OTU11)</c:v>
                </c:pt>
              </c:strCache>
            </c:strRef>
          </c:tx>
          <c:spPr>
            <a:solidFill>
              <a:schemeClr val="accent2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N$4:$W$4</c:f>
              <c:strCache>
                <c:ptCount val="10"/>
                <c:pt idx="0">
                  <c:v>S2_1</c:v>
                </c:pt>
                <c:pt idx="1">
                  <c:v>S2_2</c:v>
                </c:pt>
                <c:pt idx="2">
                  <c:v>S2_3</c:v>
                </c:pt>
                <c:pt idx="3">
                  <c:v>S2_4</c:v>
                </c:pt>
                <c:pt idx="4">
                  <c:v>S2_5</c:v>
                </c:pt>
                <c:pt idx="5">
                  <c:v>S2_6</c:v>
                </c:pt>
                <c:pt idx="6">
                  <c:v>S2_7</c:v>
                </c:pt>
                <c:pt idx="7">
                  <c:v>S2_8</c:v>
                </c:pt>
                <c:pt idx="8">
                  <c:v>S2_9</c:v>
                </c:pt>
                <c:pt idx="9">
                  <c:v>S2_10</c:v>
                </c:pt>
              </c:strCache>
            </c:strRef>
          </c:cat>
          <c:val>
            <c:numRef>
              <c:f>Blad1!$N$26:$W$26</c:f>
              <c:numCache>
                <c:formatCode>0.000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A792-4B74-AFC7-D0179422A083}"/>
            </c:ext>
          </c:extLst>
        </c:ser>
        <c:ser>
          <c:idx val="8"/>
          <c:order val="8"/>
          <c:tx>
            <c:strRef>
              <c:f>Blad1!$C$27</c:f>
              <c:strCache>
                <c:ptCount val="1"/>
                <c:pt idx="0">
                  <c:v>Lactifluus sp. (OTU14)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N$4:$W$4</c:f>
              <c:strCache>
                <c:ptCount val="10"/>
                <c:pt idx="0">
                  <c:v>S2_1</c:v>
                </c:pt>
                <c:pt idx="1">
                  <c:v>S2_2</c:v>
                </c:pt>
                <c:pt idx="2">
                  <c:v>S2_3</c:v>
                </c:pt>
                <c:pt idx="3">
                  <c:v>S2_4</c:v>
                </c:pt>
                <c:pt idx="4">
                  <c:v>S2_5</c:v>
                </c:pt>
                <c:pt idx="5">
                  <c:v>S2_6</c:v>
                </c:pt>
                <c:pt idx="6">
                  <c:v>S2_7</c:v>
                </c:pt>
                <c:pt idx="7">
                  <c:v>S2_8</c:v>
                </c:pt>
                <c:pt idx="8">
                  <c:v>S2_9</c:v>
                </c:pt>
                <c:pt idx="9">
                  <c:v>S2_10</c:v>
                </c:pt>
              </c:strCache>
            </c:strRef>
          </c:cat>
          <c:val>
            <c:numRef>
              <c:f>Blad1!$N$27:$W$27</c:f>
              <c:numCache>
                <c:formatCode>0.000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A792-4B74-AFC7-D0179422A083}"/>
            </c:ext>
          </c:extLst>
        </c:ser>
        <c:ser>
          <c:idx val="9"/>
          <c:order val="9"/>
          <c:tx>
            <c:strRef>
              <c:f>Blad1!$C$28</c:f>
              <c:strCache>
                <c:ptCount val="1"/>
                <c:pt idx="0">
                  <c:v>Plectosphaerella plurivora (OTU18)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N$4:$W$4</c:f>
              <c:strCache>
                <c:ptCount val="10"/>
                <c:pt idx="0">
                  <c:v>S2_1</c:v>
                </c:pt>
                <c:pt idx="1">
                  <c:v>S2_2</c:v>
                </c:pt>
                <c:pt idx="2">
                  <c:v>S2_3</c:v>
                </c:pt>
                <c:pt idx="3">
                  <c:v>S2_4</c:v>
                </c:pt>
                <c:pt idx="4">
                  <c:v>S2_5</c:v>
                </c:pt>
                <c:pt idx="5">
                  <c:v>S2_6</c:v>
                </c:pt>
                <c:pt idx="6">
                  <c:v>S2_7</c:v>
                </c:pt>
                <c:pt idx="7">
                  <c:v>S2_8</c:v>
                </c:pt>
                <c:pt idx="8">
                  <c:v>S2_9</c:v>
                </c:pt>
                <c:pt idx="9">
                  <c:v>S2_10</c:v>
                </c:pt>
              </c:strCache>
            </c:strRef>
          </c:cat>
          <c:val>
            <c:numRef>
              <c:f>Blad1!$N$28:$W$28</c:f>
              <c:numCache>
                <c:formatCode>0.000</c:formatCode>
                <c:ptCount val="10"/>
                <c:pt idx="0">
                  <c:v>1.1534603811434303</c:v>
                </c:pt>
                <c:pt idx="1">
                  <c:v>0</c:v>
                </c:pt>
                <c:pt idx="2">
                  <c:v>0.4012036108324975</c:v>
                </c:pt>
                <c:pt idx="3">
                  <c:v>1.2036108324974923</c:v>
                </c:pt>
                <c:pt idx="4">
                  <c:v>0.45135406218655971</c:v>
                </c:pt>
                <c:pt idx="5">
                  <c:v>0.75225677031093274</c:v>
                </c:pt>
                <c:pt idx="6">
                  <c:v>2.8585757271815444</c:v>
                </c:pt>
                <c:pt idx="7">
                  <c:v>0.75225677031093274</c:v>
                </c:pt>
                <c:pt idx="8">
                  <c:v>9.8796389167502507</c:v>
                </c:pt>
                <c:pt idx="9">
                  <c:v>3.20962888665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A792-4B74-AFC7-D0179422A083}"/>
            </c:ext>
          </c:extLst>
        </c:ser>
        <c:ser>
          <c:idx val="10"/>
          <c:order val="10"/>
          <c:tx>
            <c:strRef>
              <c:f>Blad1!$C$29</c:f>
              <c:strCache>
                <c:ptCount val="1"/>
                <c:pt idx="0">
                  <c:v>Wickerhamomyces ciferrii (OTU35)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N$4:$W$4</c:f>
              <c:strCache>
                <c:ptCount val="10"/>
                <c:pt idx="0">
                  <c:v>S2_1</c:v>
                </c:pt>
                <c:pt idx="1">
                  <c:v>S2_2</c:v>
                </c:pt>
                <c:pt idx="2">
                  <c:v>S2_3</c:v>
                </c:pt>
                <c:pt idx="3">
                  <c:v>S2_4</c:v>
                </c:pt>
                <c:pt idx="4">
                  <c:v>S2_5</c:v>
                </c:pt>
                <c:pt idx="5">
                  <c:v>S2_6</c:v>
                </c:pt>
                <c:pt idx="6">
                  <c:v>S2_7</c:v>
                </c:pt>
                <c:pt idx="7">
                  <c:v>S2_8</c:v>
                </c:pt>
                <c:pt idx="8">
                  <c:v>S2_9</c:v>
                </c:pt>
                <c:pt idx="9">
                  <c:v>S2_10</c:v>
                </c:pt>
              </c:strCache>
            </c:strRef>
          </c:cat>
          <c:val>
            <c:numRef>
              <c:f>Blad1!$N$29:$W$29</c:f>
              <c:numCache>
                <c:formatCode>0.000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A792-4B74-AFC7-D0179422A083}"/>
            </c:ext>
          </c:extLst>
        </c:ser>
        <c:ser>
          <c:idx val="11"/>
          <c:order val="11"/>
          <c:tx>
            <c:strRef>
              <c:f>Blad1!$C$30</c:f>
              <c:strCache>
                <c:ptCount val="1"/>
                <c:pt idx="0">
                  <c:v>Hypocrea lixii (OTU120)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N$4:$W$4</c:f>
              <c:strCache>
                <c:ptCount val="10"/>
                <c:pt idx="0">
                  <c:v>S2_1</c:v>
                </c:pt>
                <c:pt idx="1">
                  <c:v>S2_2</c:v>
                </c:pt>
                <c:pt idx="2">
                  <c:v>S2_3</c:v>
                </c:pt>
                <c:pt idx="3">
                  <c:v>S2_4</c:v>
                </c:pt>
                <c:pt idx="4">
                  <c:v>S2_5</c:v>
                </c:pt>
                <c:pt idx="5">
                  <c:v>S2_6</c:v>
                </c:pt>
                <c:pt idx="6">
                  <c:v>S2_7</c:v>
                </c:pt>
                <c:pt idx="7">
                  <c:v>S2_8</c:v>
                </c:pt>
                <c:pt idx="8">
                  <c:v>S2_9</c:v>
                </c:pt>
                <c:pt idx="9">
                  <c:v>S2_10</c:v>
                </c:pt>
              </c:strCache>
            </c:strRef>
          </c:cat>
          <c:val>
            <c:numRef>
              <c:f>Blad1!$N$30:$W$30</c:f>
              <c:numCache>
                <c:formatCode>0.000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A792-4B74-AFC7-D0179422A0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99810776"/>
        <c:axId val="599809792"/>
      </c:barChart>
      <c:catAx>
        <c:axId val="59981077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599809792"/>
        <c:crosses val="autoZero"/>
        <c:auto val="1"/>
        <c:lblAlgn val="ctr"/>
        <c:lblOffset val="100"/>
        <c:noMultiLvlLbl val="0"/>
      </c:catAx>
      <c:valAx>
        <c:axId val="599809792"/>
        <c:scaling>
          <c:orientation val="minMax"/>
          <c:max val="100"/>
        </c:scaling>
        <c:delete val="0"/>
        <c:axPos val="b"/>
        <c:numFmt formatCode="0.000" sourceLinked="1"/>
        <c:majorTickMark val="in"/>
        <c:minorTickMark val="in"/>
        <c:tickLblPos val="nextTo"/>
        <c:spPr>
          <a:noFill/>
          <a:ln>
            <a:solidFill>
              <a:schemeClr val="accent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599810776"/>
        <c:crosses val="autoZero"/>
        <c:crossBetween val="between"/>
      </c:valAx>
      <c:spPr>
        <a:solidFill>
          <a:schemeClr val="bg1"/>
        </a:solidFill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NL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nl-N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1528576484119259E-2"/>
          <c:y val="4.2791933184546875E-2"/>
          <c:w val="0.83599243563655667"/>
          <c:h val="0.18700879804726267"/>
        </c:manualLayout>
      </c:layout>
      <c:barChart>
        <c:barDir val="bar"/>
        <c:grouping val="stacked"/>
        <c:varyColors val="0"/>
        <c:ser>
          <c:idx val="0"/>
          <c:order val="0"/>
          <c:tx>
            <c:strRef>
              <c:f>Blad1!$C$19</c:f>
              <c:strCache>
                <c:ptCount val="1"/>
                <c:pt idx="0">
                  <c:v>Trichoderma asperelloides (OTU1)</c:v>
                </c:pt>
              </c:strCache>
            </c:strRef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cat>
            <c:strRef>
              <c:f>Blad1!$Z$4:$AA$4</c:f>
              <c:strCache>
                <c:ptCount val="2"/>
                <c:pt idx="0">
                  <c:v>S3_3</c:v>
                </c:pt>
                <c:pt idx="1">
                  <c:v>S3_8</c:v>
                </c:pt>
              </c:strCache>
            </c:strRef>
          </c:cat>
          <c:val>
            <c:numRef>
              <c:f>Blad1!$Z$20:$AA$20</c:f>
              <c:numCache>
                <c:formatCode>0.000</c:formatCode>
                <c:ptCount val="2"/>
                <c:pt idx="0">
                  <c:v>1.6549648946840523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5D5-4373-B67F-86A6FC2CA1E8}"/>
            </c:ext>
          </c:extLst>
        </c:ser>
        <c:ser>
          <c:idx val="1"/>
          <c:order val="1"/>
          <c:tx>
            <c:strRef>
              <c:f>Blad1!$C$20</c:f>
              <c:strCache>
                <c:ptCount val="1"/>
                <c:pt idx="0">
                  <c:v>Saccharomyces kudriavzevii (OTU2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Blad1!$Z$4:$AA$4</c:f>
              <c:strCache>
                <c:ptCount val="2"/>
                <c:pt idx="0">
                  <c:v>S3_3</c:v>
                </c:pt>
                <c:pt idx="1">
                  <c:v>S3_8</c:v>
                </c:pt>
              </c:strCache>
            </c:strRef>
          </c:cat>
          <c:val>
            <c:numRef>
              <c:f>Blad1!$Z$21:$AA$21</c:f>
              <c:numCache>
                <c:formatCode>0.000</c:formatCode>
                <c:ptCount val="2"/>
                <c:pt idx="0">
                  <c:v>1.3540621865596789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5D5-4373-B67F-86A6FC2CA1E8}"/>
            </c:ext>
          </c:extLst>
        </c:ser>
        <c:ser>
          <c:idx val="2"/>
          <c:order val="2"/>
          <c:tx>
            <c:strRef>
              <c:f>Blad1!$C$21</c:f>
              <c:strCache>
                <c:ptCount val="1"/>
                <c:pt idx="0">
                  <c:v>Mucor ellipsoideus (OTU4)</c:v>
                </c:pt>
              </c:strCache>
            </c:strRef>
          </c:tx>
          <c:spPr>
            <a:solidFill>
              <a:schemeClr val="accent4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Z$4:$AA$4</c:f>
              <c:strCache>
                <c:ptCount val="2"/>
                <c:pt idx="0">
                  <c:v>S3_3</c:v>
                </c:pt>
                <c:pt idx="1">
                  <c:v>S3_8</c:v>
                </c:pt>
              </c:strCache>
            </c:strRef>
          </c:cat>
          <c:val>
            <c:numRef>
              <c:f>Blad1!$Z$22:$AA$22</c:f>
              <c:numCache>
                <c:formatCode>0.000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5D5-4373-B67F-86A6FC2CA1E8}"/>
            </c:ext>
          </c:extLst>
        </c:ser>
        <c:ser>
          <c:idx val="3"/>
          <c:order val="3"/>
          <c:tx>
            <c:strRef>
              <c:f>Blad1!$C$22</c:f>
              <c:strCache>
                <c:ptCount val="1"/>
                <c:pt idx="0">
                  <c:v>Phaeolus schweinitzii (OTU5)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Blad1!$Z$4:$AA$4</c:f>
              <c:strCache>
                <c:ptCount val="2"/>
                <c:pt idx="0">
                  <c:v>S3_3</c:v>
                </c:pt>
                <c:pt idx="1">
                  <c:v>S3_8</c:v>
                </c:pt>
              </c:strCache>
            </c:strRef>
          </c:cat>
          <c:val>
            <c:numRef>
              <c:f>Blad1!$Z$23:$AA$23</c:f>
              <c:numCache>
                <c:formatCode>0.000</c:formatCode>
                <c:ptCount val="2"/>
                <c:pt idx="0">
                  <c:v>0</c:v>
                </c:pt>
                <c:pt idx="1">
                  <c:v>51.5045135406218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5D5-4373-B67F-86A6FC2CA1E8}"/>
            </c:ext>
          </c:extLst>
        </c:ser>
        <c:ser>
          <c:idx val="4"/>
          <c:order val="4"/>
          <c:tx>
            <c:strRef>
              <c:f>Blad1!$C$23</c:f>
              <c:strCache>
                <c:ptCount val="1"/>
                <c:pt idx="0">
                  <c:v>Tuber regianum (OTU6)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Blad1!$Z$4:$AA$4</c:f>
              <c:strCache>
                <c:ptCount val="2"/>
                <c:pt idx="0">
                  <c:v>S3_3</c:v>
                </c:pt>
                <c:pt idx="1">
                  <c:v>S3_8</c:v>
                </c:pt>
              </c:strCache>
            </c:strRef>
          </c:cat>
          <c:val>
            <c:numRef>
              <c:f>Blad1!$Z$24:$AA$24</c:f>
              <c:numCache>
                <c:formatCode>0.000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5D5-4373-B67F-86A6FC2CA1E8}"/>
            </c:ext>
          </c:extLst>
        </c:ser>
        <c:ser>
          <c:idx val="5"/>
          <c:order val="5"/>
          <c:tx>
            <c:strRef>
              <c:f>Blad1!$C$24</c:f>
              <c:strCache>
                <c:ptCount val="1"/>
                <c:pt idx="0">
                  <c:v>Leccinum rndifoliae (OTU7)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Blad1!$Z$4:$AA$4</c:f>
              <c:strCache>
                <c:ptCount val="2"/>
                <c:pt idx="0">
                  <c:v>S3_3</c:v>
                </c:pt>
                <c:pt idx="1">
                  <c:v>S3_8</c:v>
                </c:pt>
              </c:strCache>
            </c:strRef>
          </c:cat>
          <c:val>
            <c:numRef>
              <c:f>Blad1!$Z$25:$AA$25</c:f>
              <c:numCache>
                <c:formatCode>0.000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05D5-4373-B67F-86A6FC2CA1E8}"/>
            </c:ext>
          </c:extLst>
        </c:ser>
        <c:ser>
          <c:idx val="6"/>
          <c:order val="6"/>
          <c:tx>
            <c:strRef>
              <c:f>Blad1!$C$25</c:f>
              <c:strCache>
                <c:ptCount val="1"/>
                <c:pt idx="0">
                  <c:v>Penicillium dipodomyis (OTU8)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Z$4:$AA$4</c:f>
              <c:strCache>
                <c:ptCount val="2"/>
                <c:pt idx="0">
                  <c:v>S3_3</c:v>
                </c:pt>
                <c:pt idx="1">
                  <c:v>S3_8</c:v>
                </c:pt>
              </c:strCache>
            </c:strRef>
          </c:cat>
          <c:val>
            <c:numRef>
              <c:f>Blad1!$Z$26:$AA$26</c:f>
              <c:numCache>
                <c:formatCode>0.000</c:formatCode>
                <c:ptCount val="2"/>
                <c:pt idx="0">
                  <c:v>55.616850551654963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05D5-4373-B67F-86A6FC2CA1E8}"/>
            </c:ext>
          </c:extLst>
        </c:ser>
        <c:ser>
          <c:idx val="7"/>
          <c:order val="7"/>
          <c:tx>
            <c:strRef>
              <c:f>Blad1!$C$26</c:f>
              <c:strCache>
                <c:ptCount val="1"/>
                <c:pt idx="0">
                  <c:v>Lactariusfumosibrunneus (OTU11)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Z$4:$AA$4</c:f>
              <c:strCache>
                <c:ptCount val="2"/>
                <c:pt idx="0">
                  <c:v>S3_3</c:v>
                </c:pt>
                <c:pt idx="1">
                  <c:v>S3_8</c:v>
                </c:pt>
              </c:strCache>
            </c:strRef>
          </c:cat>
          <c:val>
            <c:numRef>
              <c:f>Blad1!$Z$27:$AA$27</c:f>
              <c:numCache>
                <c:formatCode>0.000</c:formatCode>
                <c:ptCount val="2"/>
                <c:pt idx="0">
                  <c:v>0</c:v>
                </c:pt>
                <c:pt idx="1">
                  <c:v>27.1815446339017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05D5-4373-B67F-86A6FC2CA1E8}"/>
            </c:ext>
          </c:extLst>
        </c:ser>
        <c:ser>
          <c:idx val="8"/>
          <c:order val="8"/>
          <c:tx>
            <c:strRef>
              <c:f>Blad1!$C$27</c:f>
              <c:strCache>
                <c:ptCount val="1"/>
                <c:pt idx="0">
                  <c:v>Lactifluus sp. (OTU14)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Blad1!$Z$4:$AA$4</c:f>
              <c:strCache>
                <c:ptCount val="2"/>
                <c:pt idx="0">
                  <c:v>S3_3</c:v>
                </c:pt>
                <c:pt idx="1">
                  <c:v>S3_8</c:v>
                </c:pt>
              </c:strCache>
            </c:strRef>
          </c:cat>
          <c:val>
            <c:numRef>
              <c:f>Blad1!$Z$28:$AA$28</c:f>
              <c:numCache>
                <c:formatCode>0.000</c:formatCode>
                <c:ptCount val="2"/>
                <c:pt idx="0">
                  <c:v>0</c:v>
                </c:pt>
                <c:pt idx="1">
                  <c:v>9.32798395185556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05D5-4373-B67F-86A6FC2CA1E8}"/>
            </c:ext>
          </c:extLst>
        </c:ser>
        <c:ser>
          <c:idx val="9"/>
          <c:order val="9"/>
          <c:tx>
            <c:strRef>
              <c:f>Blad1!$C$28</c:f>
              <c:strCache>
                <c:ptCount val="1"/>
                <c:pt idx="0">
                  <c:v>Plectosphaerella plurivora (OTU18)</c:v>
                </c:pt>
              </c:strCache>
            </c:strRef>
          </c:tx>
          <c:spPr>
            <a:solidFill>
              <a:schemeClr val="accent4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Z$4:$AA$4</c:f>
              <c:strCache>
                <c:ptCount val="2"/>
                <c:pt idx="0">
                  <c:v>S3_3</c:v>
                </c:pt>
                <c:pt idx="1">
                  <c:v>S3_8</c:v>
                </c:pt>
              </c:strCache>
            </c:strRef>
          </c:cat>
          <c:val>
            <c:numRef>
              <c:f>Blad1!$Z$29:$AA$29</c:f>
              <c:numCache>
                <c:formatCode>0.000</c:formatCode>
                <c:ptCount val="2"/>
                <c:pt idx="0">
                  <c:v>0</c:v>
                </c:pt>
                <c:pt idx="1">
                  <c:v>9.97993981945837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05D5-4373-B67F-86A6FC2CA1E8}"/>
            </c:ext>
          </c:extLst>
        </c:ser>
        <c:ser>
          <c:idx val="10"/>
          <c:order val="10"/>
          <c:tx>
            <c:strRef>
              <c:f>Blad1!$C$29</c:f>
              <c:strCache>
                <c:ptCount val="1"/>
                <c:pt idx="0">
                  <c:v>Wickerhamomyces ciferrii (OTU35)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Blad1!$Z$4:$AA$4</c:f>
              <c:strCache>
                <c:ptCount val="2"/>
                <c:pt idx="0">
                  <c:v>S3_3</c:v>
                </c:pt>
                <c:pt idx="1">
                  <c:v>S3_8</c:v>
                </c:pt>
              </c:strCache>
            </c:strRef>
          </c:cat>
          <c:val>
            <c:numRef>
              <c:f>Blad1!$Z$30:$AA$30</c:f>
              <c:numCache>
                <c:formatCode>0.000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05D5-4373-B67F-86A6FC2CA1E8}"/>
            </c:ext>
          </c:extLst>
        </c:ser>
        <c:ser>
          <c:idx val="11"/>
          <c:order val="11"/>
          <c:tx>
            <c:strRef>
              <c:f>Blad1!$C$30</c:f>
              <c:strCache>
                <c:ptCount val="1"/>
                <c:pt idx="0">
                  <c:v>Hypocrea lixii (OTU120)</c:v>
                </c:pt>
              </c:strCache>
            </c:strRef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val>
            <c:numRef>
              <c:f>Blad1!$Z$30:$AA$30</c:f>
              <c:numCache>
                <c:formatCode>0.000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05D5-4373-B67F-86A6FC2CA1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483411968"/>
        <c:axId val="483407376"/>
      </c:barChart>
      <c:catAx>
        <c:axId val="48341196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483407376"/>
        <c:crossesAt val="0"/>
        <c:auto val="1"/>
        <c:lblAlgn val="ctr"/>
        <c:lblOffset val="100"/>
        <c:noMultiLvlLbl val="0"/>
      </c:catAx>
      <c:valAx>
        <c:axId val="483407376"/>
        <c:scaling>
          <c:orientation val="minMax"/>
          <c:max val="100"/>
        </c:scaling>
        <c:delete val="0"/>
        <c:axPos val="b"/>
        <c:numFmt formatCode="0.000" sourceLinked="1"/>
        <c:majorTickMark val="in"/>
        <c:minorTickMark val="in"/>
        <c:tickLblPos val="nextTo"/>
        <c:spPr>
          <a:noFill/>
          <a:ln>
            <a:solidFill>
              <a:schemeClr val="accent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483411968"/>
        <c:crosses val="autoZero"/>
        <c:crossBetween val="between"/>
      </c:valAx>
      <c:spPr>
        <a:solidFill>
          <a:schemeClr val="bg1"/>
        </a:solidFill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6081499261973534"/>
          <c:y val="0.37723591488579022"/>
          <c:w val="0.66408925884750925"/>
          <c:h val="0.595389934359516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nl-N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N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A2C07C5-2086-46E3-B84E-060FC82B98F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B3BB2DF4-89F9-447B-8ED3-E49021560A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E1C324D9-CAD8-4AEA-8BD6-B8A5B3F589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8ECE9-7D0A-4518-A648-F76AF3EEA858}" type="datetimeFigureOut">
              <a:rPr lang="nl-NL" smtClean="0"/>
              <a:t>30-8-2018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638FE2DB-6F1A-478B-87EA-C02A6A8E87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69EA68E0-C099-4C50-AF15-53348B3E8F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21B72-2B19-4E30-98F7-C0B63C86F96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56248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F0739A5-95DF-4C87-9EC9-CA6E45FD9E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79744823-E07D-4962-BABB-A828F92364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475BE0D4-2CA8-4AF5-9EE3-207388ED5C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8ECE9-7D0A-4518-A648-F76AF3EEA858}" type="datetimeFigureOut">
              <a:rPr lang="nl-NL" smtClean="0"/>
              <a:t>30-8-2018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47A93287-955F-4207-A711-1F52155AA1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A98DA914-DFF9-4DE2-928E-C05331072D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21B72-2B19-4E30-98F7-C0B63C86F96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263773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>
            <a:extLst>
              <a:ext uri="{FF2B5EF4-FFF2-40B4-BE49-F238E27FC236}">
                <a16:creationId xmlns:a16="http://schemas.microsoft.com/office/drawing/2014/main" id="{E5533739-C202-4BFD-945F-C2AC44DECB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72F8D076-1A7A-40AC-B3E4-527F96AF3A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71B14AF9-4C41-4AF6-90C5-41C68EB958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8ECE9-7D0A-4518-A648-F76AF3EEA858}" type="datetimeFigureOut">
              <a:rPr lang="nl-NL" smtClean="0"/>
              <a:t>30-8-2018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A628846A-D335-49DC-A1E6-859EAB3865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E7526D7D-7D5C-4043-B13B-06081C828D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21B72-2B19-4E30-98F7-C0B63C86F96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768701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5DBFB26-2764-48B7-9537-86B7777F80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58CFB0E5-C0BA-4E85-B460-819A4C6870E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3A21F3D9-A427-476C-9283-6E04EC69B1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8ECE9-7D0A-4518-A648-F76AF3EEA858}" type="datetimeFigureOut">
              <a:rPr lang="nl-NL" smtClean="0"/>
              <a:t>30-8-2018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06B5AEBF-D676-4DA7-A735-D900747CAC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BE68C356-71D5-42BD-A3B6-A196765000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21B72-2B19-4E30-98F7-C0B63C86F96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619112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18D379D-2F8C-4BBB-BAB9-8D2D46B9ED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4F172531-18F3-4B12-9883-D9834E0DD4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00E9DA99-939A-441C-8D37-F29E5306F5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8ECE9-7D0A-4518-A648-F76AF3EEA858}" type="datetimeFigureOut">
              <a:rPr lang="nl-NL" smtClean="0"/>
              <a:t>30-8-2018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B5F17DB4-BF41-43EA-9758-ADDC15FA0C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0ADA9B9C-D0A8-491E-987A-8EDC75BBBE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21B72-2B19-4E30-98F7-C0B63C86F96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118167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A0CE182-257F-4509-85EE-22CC81D8BF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1364D760-85E1-46BD-8B25-D3AB4050C27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7991776D-69A0-4EBE-A70F-0CF8973F69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3DB7D705-59DC-4F8A-B647-2FE27C12B8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8ECE9-7D0A-4518-A648-F76AF3EEA858}" type="datetimeFigureOut">
              <a:rPr lang="nl-NL" smtClean="0"/>
              <a:t>30-8-2018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EF19F8B0-64F3-4D1F-8292-878E8E80B2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049AEA8D-0050-442B-B3A6-200CE9A201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21B72-2B19-4E30-98F7-C0B63C86F96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40101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8717625-6577-414C-AABB-7476B020AF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FB912DE6-E24F-49DD-B103-FFB386B55A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285EC958-A965-4ABE-9E71-995741BBCB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DFA9DAAB-32E2-42F9-AA34-D7BA6908842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E3536CCF-B2EE-4D9C-8DC1-FCDC9C038AA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7" name="Tijdelijke aanduiding voor datum 6">
            <a:extLst>
              <a:ext uri="{FF2B5EF4-FFF2-40B4-BE49-F238E27FC236}">
                <a16:creationId xmlns:a16="http://schemas.microsoft.com/office/drawing/2014/main" id="{D3660CC2-111F-4476-887A-CE04D8C459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8ECE9-7D0A-4518-A648-F76AF3EEA858}" type="datetimeFigureOut">
              <a:rPr lang="nl-NL" smtClean="0"/>
              <a:t>30-8-2018</a:t>
            </a:fld>
            <a:endParaRPr lang="nl-NL"/>
          </a:p>
        </p:txBody>
      </p:sp>
      <p:sp>
        <p:nvSpPr>
          <p:cNvPr id="8" name="Tijdelijke aanduiding voor voettekst 7">
            <a:extLst>
              <a:ext uri="{FF2B5EF4-FFF2-40B4-BE49-F238E27FC236}">
                <a16:creationId xmlns:a16="http://schemas.microsoft.com/office/drawing/2014/main" id="{26B7E755-CC4D-4E1C-BB69-58C2A870D7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>
            <a:extLst>
              <a:ext uri="{FF2B5EF4-FFF2-40B4-BE49-F238E27FC236}">
                <a16:creationId xmlns:a16="http://schemas.microsoft.com/office/drawing/2014/main" id="{ADFD3CCC-CF1F-4E70-9B81-6E1C03A76D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21B72-2B19-4E30-98F7-C0B63C86F96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861122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CC3A627-38B9-46BD-8463-C725E37FF4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B4F46FE8-CED3-4108-8B3E-01740A9940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8ECE9-7D0A-4518-A648-F76AF3EEA858}" type="datetimeFigureOut">
              <a:rPr lang="nl-NL" smtClean="0"/>
              <a:t>30-8-2018</a:t>
            </a:fld>
            <a:endParaRPr lang="nl-NL"/>
          </a:p>
        </p:txBody>
      </p:sp>
      <p:sp>
        <p:nvSpPr>
          <p:cNvPr id="4" name="Tijdelijke aanduiding voor voettekst 3">
            <a:extLst>
              <a:ext uri="{FF2B5EF4-FFF2-40B4-BE49-F238E27FC236}">
                <a16:creationId xmlns:a16="http://schemas.microsoft.com/office/drawing/2014/main" id="{DE20F663-1C41-4031-834E-A96A9D28D7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>
            <a:extLst>
              <a:ext uri="{FF2B5EF4-FFF2-40B4-BE49-F238E27FC236}">
                <a16:creationId xmlns:a16="http://schemas.microsoft.com/office/drawing/2014/main" id="{40D129EB-EA0E-4E1A-99B4-AE5B981775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21B72-2B19-4E30-98F7-C0B63C86F96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951414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>
            <a:extLst>
              <a:ext uri="{FF2B5EF4-FFF2-40B4-BE49-F238E27FC236}">
                <a16:creationId xmlns:a16="http://schemas.microsoft.com/office/drawing/2014/main" id="{5E8D6389-0BA5-48C7-AF9A-449A507364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8ECE9-7D0A-4518-A648-F76AF3EEA858}" type="datetimeFigureOut">
              <a:rPr lang="nl-NL" smtClean="0"/>
              <a:t>30-8-2018</a:t>
            </a:fld>
            <a:endParaRPr lang="nl-NL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:a16="http://schemas.microsoft.com/office/drawing/2014/main" id="{F177B1E7-0B32-444A-94D8-E4E0419BAA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84896A85-84FE-4A51-9FDD-2AC3A81E14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21B72-2B19-4E30-98F7-C0B63C86F96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0695610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556DC24-86FB-4861-A251-971A18038B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B2867BAC-336C-4BD7-999B-86C6844627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1329C44A-4FEA-4DF3-B2B3-66D15EAE77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BC741471-699D-4FE4-AD9A-47F5638D7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8ECE9-7D0A-4518-A648-F76AF3EEA858}" type="datetimeFigureOut">
              <a:rPr lang="nl-NL" smtClean="0"/>
              <a:t>30-8-2018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F1F912FE-0B1D-4774-A406-BBB085EB63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4D456B1A-63C6-4D45-82AF-E07D597794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21B72-2B19-4E30-98F7-C0B63C86F96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4738025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9FB9122-1094-436B-A614-31A0E8AC6C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DAC26178-044B-4D76-96ED-EA42621F39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1A6A0286-F34C-4081-A579-9AA2E286CF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Tekststijl van het model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3BE6CEB8-BC9F-4C50-A357-A25120D9D9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8ECE9-7D0A-4518-A648-F76AF3EEA858}" type="datetimeFigureOut">
              <a:rPr lang="nl-NL" smtClean="0"/>
              <a:t>30-8-2018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5B4F935E-7390-48CE-8BC6-0ED8DDBBA3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72513C70-A45D-42F7-B3CE-889D81B077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521B72-2B19-4E30-98F7-C0B63C86F96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67136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400904CB-D4A6-4B77-AF30-254BE0F21F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68AA233D-3C4E-4CBF-ADEC-C3EA061EDF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Tekststijl van het model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F2546367-E033-401D-AF34-315FEA40E09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E8ECE9-7D0A-4518-A648-F76AF3EEA858}" type="datetimeFigureOut">
              <a:rPr lang="nl-NL" smtClean="0"/>
              <a:t>30-8-2018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4261DFBA-8B6C-4A7B-8D4A-CF4A2E36887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3B71FC93-23C7-4877-9ADD-15DC8DE2625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521B72-2B19-4E30-98F7-C0B63C86F96F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6050968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kstvak 5">
            <a:extLst>
              <a:ext uri="{FF2B5EF4-FFF2-40B4-BE49-F238E27FC236}">
                <a16:creationId xmlns:a16="http://schemas.microsoft.com/office/drawing/2014/main" id="{99A37656-88CC-4D83-B9CB-21161F6C39E5}"/>
              </a:ext>
            </a:extLst>
          </p:cNvPr>
          <p:cNvSpPr txBox="1"/>
          <p:nvPr/>
        </p:nvSpPr>
        <p:spPr>
          <a:xfrm>
            <a:off x="2309004" y="477104"/>
            <a:ext cx="12189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B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/>
              <a:t>Forest Locations</a:t>
            </a:r>
            <a:endParaRPr lang="nl-NL" sz="1200" b="1" dirty="0"/>
          </a:p>
        </p:txBody>
      </p:sp>
      <p:sp>
        <p:nvSpPr>
          <p:cNvPr id="5" name="Tekstvak 5">
            <a:extLst>
              <a:ext uri="{FF2B5EF4-FFF2-40B4-BE49-F238E27FC236}">
                <a16:creationId xmlns:a16="http://schemas.microsoft.com/office/drawing/2014/main" id="{99A37656-88CC-4D83-B9CB-21161F6C39E5}"/>
              </a:ext>
            </a:extLst>
          </p:cNvPr>
          <p:cNvSpPr txBox="1"/>
          <p:nvPr/>
        </p:nvSpPr>
        <p:spPr>
          <a:xfrm>
            <a:off x="8153151" y="338604"/>
            <a:ext cx="12227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nl-B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/>
              <a:t>Urban Locations</a:t>
            </a:r>
            <a:endParaRPr lang="nl-NL" sz="1200" b="1" dirty="0"/>
          </a:p>
        </p:txBody>
      </p:sp>
      <p:graphicFrame>
        <p:nvGraphicFramePr>
          <p:cNvPr id="6" name="Grafiek 5">
            <a:extLst>
              <a:ext uri="{FF2B5EF4-FFF2-40B4-BE49-F238E27FC236}">
                <a16:creationId xmlns:a16="http://schemas.microsoft.com/office/drawing/2014/main" id="{A4779A89-8C02-4F9E-A8D0-FA52DB0B035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83964469"/>
              </p:ext>
            </p:extLst>
          </p:nvPr>
        </p:nvGraphicFramePr>
        <p:xfrm>
          <a:off x="341552" y="477104"/>
          <a:ext cx="5567542" cy="30903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Grafiek 7">
            <a:extLst>
              <a:ext uri="{FF2B5EF4-FFF2-40B4-BE49-F238E27FC236}">
                <a16:creationId xmlns:a16="http://schemas.microsoft.com/office/drawing/2014/main" id="{00789BB5-844A-41B2-A632-92A05057576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81668251"/>
              </p:ext>
            </p:extLst>
          </p:nvPr>
        </p:nvGraphicFramePr>
        <p:xfrm>
          <a:off x="118398" y="3429000"/>
          <a:ext cx="5790696" cy="33439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Grafiek 8">
            <a:extLst>
              <a:ext uri="{FF2B5EF4-FFF2-40B4-BE49-F238E27FC236}">
                <a16:creationId xmlns:a16="http://schemas.microsoft.com/office/drawing/2014/main" id="{CC97DF40-89F6-49AA-B177-AD84EBEDF92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31056741"/>
              </p:ext>
            </p:extLst>
          </p:nvPr>
        </p:nvGraphicFramePr>
        <p:xfrm>
          <a:off x="6132248" y="615603"/>
          <a:ext cx="5335852" cy="41754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" name="Tabel 3">
            <a:extLst>
              <a:ext uri="{FF2B5EF4-FFF2-40B4-BE49-F238E27FC236}">
                <a16:creationId xmlns:a16="http://schemas.microsoft.com/office/drawing/2014/main" id="{BCC56BC1-E50D-4A1F-B1DF-D84F1FD6605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85568870"/>
              </p:ext>
            </p:extLst>
          </p:nvPr>
        </p:nvGraphicFramePr>
        <p:xfrm>
          <a:off x="8025507" y="2178649"/>
          <a:ext cx="2076026" cy="246236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076026">
                  <a:extLst>
                    <a:ext uri="{9D8B030D-6E8A-4147-A177-3AD203B41FA5}">
                      <a16:colId xmlns:a16="http://schemas.microsoft.com/office/drawing/2014/main" val="1165863818"/>
                    </a:ext>
                  </a:extLst>
                </a:gridCol>
              </a:tblGrid>
              <a:tr h="205197">
                <a:tc>
                  <a:txBody>
                    <a:bodyPr/>
                    <a:lstStyle/>
                    <a:p>
                      <a:pPr algn="l" fontAlgn="b"/>
                      <a:r>
                        <a:rPr lang="nl-NL" sz="1100" i="1" u="none" strike="noStrike" dirty="0" err="1">
                          <a:effectLst/>
                        </a:rPr>
                        <a:t>Trichoderma</a:t>
                      </a:r>
                      <a:r>
                        <a:rPr lang="nl-NL" sz="1100" i="1" u="none" strike="noStrike" dirty="0">
                          <a:effectLst/>
                        </a:rPr>
                        <a:t> </a:t>
                      </a:r>
                      <a:r>
                        <a:rPr lang="nl-NL" sz="1100" i="0" u="none" strike="noStrike" dirty="0" err="1">
                          <a:effectLst/>
                        </a:rPr>
                        <a:t>sp</a:t>
                      </a:r>
                      <a:r>
                        <a:rPr lang="nl-NL" sz="1100" i="0" u="none" strike="noStrike" dirty="0">
                          <a:effectLst/>
                        </a:rPr>
                        <a:t>. </a:t>
                      </a:r>
                      <a:r>
                        <a:rPr lang="nl-NL" sz="1100" u="none" strike="noStrike" dirty="0">
                          <a:effectLst/>
                        </a:rPr>
                        <a:t>(OTU1)</a:t>
                      </a:r>
                      <a:endParaRPr lang="nl-NL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7895243"/>
                  </a:ext>
                </a:extLst>
              </a:tr>
              <a:tr h="205197">
                <a:tc>
                  <a:txBody>
                    <a:bodyPr/>
                    <a:lstStyle/>
                    <a:p>
                      <a:pPr algn="l" fontAlgn="b"/>
                      <a:r>
                        <a:rPr lang="nl-NL" sz="1100" i="1" u="none" strike="noStrike" dirty="0" err="1">
                          <a:effectLst/>
                        </a:rPr>
                        <a:t>Saccharomyces</a:t>
                      </a:r>
                      <a:r>
                        <a:rPr lang="nl-NL" sz="1100" i="1" u="none" strike="noStrike" dirty="0">
                          <a:effectLst/>
                        </a:rPr>
                        <a:t> </a:t>
                      </a:r>
                      <a:r>
                        <a:rPr lang="nl-NL" sz="1100" i="0" u="none" strike="noStrike" dirty="0" err="1">
                          <a:effectLst/>
                        </a:rPr>
                        <a:t>sp</a:t>
                      </a:r>
                      <a:r>
                        <a:rPr lang="nl-NL" sz="1100" i="1" u="none" strike="noStrike" dirty="0">
                          <a:effectLst/>
                        </a:rPr>
                        <a:t>.</a:t>
                      </a:r>
                      <a:r>
                        <a:rPr lang="nl-NL" sz="1100" u="none" strike="noStrike" dirty="0">
                          <a:effectLst/>
                        </a:rPr>
                        <a:t>(OTU2)</a:t>
                      </a:r>
                      <a:endParaRPr lang="nl-NL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0231933"/>
                  </a:ext>
                </a:extLst>
              </a:tr>
              <a:tr h="205197">
                <a:tc>
                  <a:txBody>
                    <a:bodyPr/>
                    <a:lstStyle/>
                    <a:p>
                      <a:pPr algn="l" fontAlgn="b"/>
                      <a:r>
                        <a:rPr lang="nl-NL" sz="1100" i="1" u="none" strike="noStrike" dirty="0" err="1">
                          <a:effectLst/>
                        </a:rPr>
                        <a:t>Mucor</a:t>
                      </a:r>
                      <a:r>
                        <a:rPr lang="nl-NL" sz="1100" i="1" u="none" strike="noStrike" dirty="0">
                          <a:effectLst/>
                        </a:rPr>
                        <a:t> </a:t>
                      </a:r>
                      <a:r>
                        <a:rPr lang="nl-NL" sz="1100" i="0" u="none" strike="noStrike" dirty="0" err="1">
                          <a:effectLst/>
                        </a:rPr>
                        <a:t>sp</a:t>
                      </a:r>
                      <a:r>
                        <a:rPr lang="nl-NL" sz="1100" i="0" u="none" strike="noStrike" dirty="0">
                          <a:effectLst/>
                        </a:rPr>
                        <a:t>. </a:t>
                      </a:r>
                      <a:r>
                        <a:rPr lang="nl-NL" sz="1100" u="none" strike="noStrike" dirty="0">
                          <a:effectLst/>
                        </a:rPr>
                        <a:t>(OTU4)</a:t>
                      </a:r>
                      <a:endParaRPr lang="nl-NL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300061"/>
                  </a:ext>
                </a:extLst>
              </a:tr>
              <a:tr h="205197">
                <a:tc>
                  <a:txBody>
                    <a:bodyPr/>
                    <a:lstStyle/>
                    <a:p>
                      <a:pPr algn="l" fontAlgn="b"/>
                      <a:r>
                        <a:rPr lang="nl-NL" sz="1100" i="1" u="none" strike="noStrike" dirty="0" err="1">
                          <a:effectLst/>
                        </a:rPr>
                        <a:t>Phaeolus</a:t>
                      </a:r>
                      <a:r>
                        <a:rPr lang="nl-NL" sz="1100" i="1" u="none" strike="noStrike" dirty="0">
                          <a:effectLst/>
                        </a:rPr>
                        <a:t> </a:t>
                      </a:r>
                      <a:r>
                        <a:rPr lang="nl-NL" sz="1100" i="0" u="none" strike="noStrike" dirty="0" err="1">
                          <a:effectLst/>
                        </a:rPr>
                        <a:t>sp</a:t>
                      </a:r>
                      <a:r>
                        <a:rPr lang="nl-NL" sz="1100" i="0" u="none" strike="noStrike" dirty="0">
                          <a:effectLst/>
                        </a:rPr>
                        <a:t>. </a:t>
                      </a:r>
                      <a:r>
                        <a:rPr lang="nl-NL" sz="1100" u="none" strike="noStrike" dirty="0">
                          <a:effectLst/>
                        </a:rPr>
                        <a:t>(OTU5)</a:t>
                      </a:r>
                      <a:endParaRPr lang="nl-NL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43991176"/>
                  </a:ext>
                </a:extLst>
              </a:tr>
              <a:tr h="205197">
                <a:tc>
                  <a:txBody>
                    <a:bodyPr/>
                    <a:lstStyle/>
                    <a:p>
                      <a:pPr algn="l" fontAlgn="b"/>
                      <a:r>
                        <a:rPr lang="nl-NL" sz="1100" i="1" u="none" strike="noStrike" dirty="0" err="1">
                          <a:effectLst/>
                        </a:rPr>
                        <a:t>Tuber</a:t>
                      </a:r>
                      <a:r>
                        <a:rPr lang="nl-NL" sz="1100" i="1" u="none" strike="noStrike" dirty="0">
                          <a:effectLst/>
                        </a:rPr>
                        <a:t> </a:t>
                      </a:r>
                      <a:r>
                        <a:rPr lang="nl-NL" sz="1100" i="0" u="none" strike="noStrike" dirty="0" err="1">
                          <a:effectLst/>
                        </a:rPr>
                        <a:t>sp</a:t>
                      </a:r>
                      <a:r>
                        <a:rPr lang="nl-NL" sz="1100" i="1" u="none" strike="noStrike" dirty="0">
                          <a:effectLst/>
                        </a:rPr>
                        <a:t>. </a:t>
                      </a:r>
                      <a:r>
                        <a:rPr lang="nl-NL" sz="1100" u="none" strike="noStrike" dirty="0">
                          <a:effectLst/>
                        </a:rPr>
                        <a:t>(OTU6)</a:t>
                      </a:r>
                      <a:endParaRPr lang="nl-NL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8961664"/>
                  </a:ext>
                </a:extLst>
              </a:tr>
              <a:tr h="205197">
                <a:tc>
                  <a:txBody>
                    <a:bodyPr/>
                    <a:lstStyle/>
                    <a:p>
                      <a:pPr algn="l" fontAlgn="b"/>
                      <a:r>
                        <a:rPr lang="nl-NL" sz="1100" i="1" u="none" strike="noStrike" dirty="0" err="1">
                          <a:effectLst/>
                        </a:rPr>
                        <a:t>Leccinum</a:t>
                      </a:r>
                      <a:r>
                        <a:rPr lang="nl-NL" sz="1100" i="1" u="none" strike="noStrike" dirty="0">
                          <a:effectLst/>
                        </a:rPr>
                        <a:t> </a:t>
                      </a:r>
                      <a:r>
                        <a:rPr lang="nl-NL" sz="1100" i="0" u="none" strike="noStrike" dirty="0" err="1">
                          <a:effectLst/>
                        </a:rPr>
                        <a:t>sp</a:t>
                      </a:r>
                      <a:r>
                        <a:rPr lang="nl-NL" sz="1100" i="0" u="none" strike="noStrike" dirty="0">
                          <a:effectLst/>
                        </a:rPr>
                        <a:t>. </a:t>
                      </a:r>
                      <a:r>
                        <a:rPr lang="nl-NL" sz="1100" u="none" strike="noStrike" dirty="0">
                          <a:effectLst/>
                        </a:rPr>
                        <a:t>(OTU7)</a:t>
                      </a:r>
                      <a:endParaRPr lang="nl-NL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80676864"/>
                  </a:ext>
                </a:extLst>
              </a:tr>
              <a:tr h="205197">
                <a:tc>
                  <a:txBody>
                    <a:bodyPr/>
                    <a:lstStyle/>
                    <a:p>
                      <a:pPr algn="l" fontAlgn="b"/>
                      <a:r>
                        <a:rPr lang="nl-NL" sz="1100" i="1" u="none" strike="noStrike" dirty="0" err="1">
                          <a:effectLst/>
                        </a:rPr>
                        <a:t>Penicillium</a:t>
                      </a:r>
                      <a:r>
                        <a:rPr lang="nl-NL" sz="1100" i="1" u="none" strike="noStrike" dirty="0">
                          <a:effectLst/>
                        </a:rPr>
                        <a:t> </a:t>
                      </a:r>
                      <a:r>
                        <a:rPr lang="nl-NL" sz="1100" i="0" u="none" strike="noStrike" dirty="0" err="1">
                          <a:effectLst/>
                        </a:rPr>
                        <a:t>sp</a:t>
                      </a:r>
                      <a:r>
                        <a:rPr lang="nl-NL" sz="1100" i="1" u="none" strike="noStrike" dirty="0">
                          <a:effectLst/>
                        </a:rPr>
                        <a:t>. </a:t>
                      </a:r>
                      <a:r>
                        <a:rPr lang="nl-NL" sz="1100" u="none" strike="noStrike" dirty="0">
                          <a:effectLst/>
                        </a:rPr>
                        <a:t>(OTU8)</a:t>
                      </a:r>
                      <a:endParaRPr lang="nl-NL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73915838"/>
                  </a:ext>
                </a:extLst>
              </a:tr>
              <a:tr h="205197">
                <a:tc>
                  <a:txBody>
                    <a:bodyPr/>
                    <a:lstStyle/>
                    <a:p>
                      <a:pPr algn="l" fontAlgn="b"/>
                      <a:r>
                        <a:rPr lang="nl-NL" sz="1100" i="1" u="none" strike="noStrike" dirty="0" err="1">
                          <a:effectLst/>
                        </a:rPr>
                        <a:t>Lactariusfumosibrunneus</a:t>
                      </a:r>
                      <a:r>
                        <a:rPr lang="nl-NL" sz="1100" u="none" strike="noStrike" dirty="0">
                          <a:effectLst/>
                        </a:rPr>
                        <a:t> (OTU11)</a:t>
                      </a:r>
                      <a:endParaRPr lang="nl-NL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8716053"/>
                  </a:ext>
                </a:extLst>
              </a:tr>
              <a:tr h="205197">
                <a:tc>
                  <a:txBody>
                    <a:bodyPr/>
                    <a:lstStyle/>
                    <a:p>
                      <a:pPr algn="l" fontAlgn="b"/>
                      <a:r>
                        <a:rPr lang="nl-NL" sz="1100" i="1" u="none" strike="noStrike" dirty="0" err="1">
                          <a:effectLst/>
                        </a:rPr>
                        <a:t>Lactifluus</a:t>
                      </a:r>
                      <a:r>
                        <a:rPr lang="nl-NL" sz="1100" u="none" strike="noStrike" dirty="0">
                          <a:effectLst/>
                        </a:rPr>
                        <a:t> </a:t>
                      </a:r>
                      <a:r>
                        <a:rPr lang="nl-NL" sz="1100" u="none" strike="noStrike" dirty="0" err="1">
                          <a:effectLst/>
                        </a:rPr>
                        <a:t>sp</a:t>
                      </a:r>
                      <a:r>
                        <a:rPr lang="nl-NL" sz="1100" u="none" strike="noStrike" dirty="0">
                          <a:effectLst/>
                        </a:rPr>
                        <a:t>. (OTU14)</a:t>
                      </a:r>
                      <a:endParaRPr lang="nl-NL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4327983"/>
                  </a:ext>
                </a:extLst>
              </a:tr>
              <a:tr h="205197">
                <a:tc>
                  <a:txBody>
                    <a:bodyPr/>
                    <a:lstStyle/>
                    <a:p>
                      <a:pPr algn="l" fontAlgn="b"/>
                      <a:r>
                        <a:rPr lang="nl-NL" sz="1100" i="1" u="none" strike="noStrike" dirty="0" err="1">
                          <a:effectLst/>
                        </a:rPr>
                        <a:t>Plectosphaerella</a:t>
                      </a:r>
                      <a:r>
                        <a:rPr lang="nl-NL" sz="1100" i="1" u="none" strike="noStrike" dirty="0">
                          <a:effectLst/>
                        </a:rPr>
                        <a:t> </a:t>
                      </a:r>
                      <a:r>
                        <a:rPr lang="nl-NL" sz="1100" i="0" u="none" strike="noStrike" dirty="0" err="1">
                          <a:effectLst/>
                        </a:rPr>
                        <a:t>sp</a:t>
                      </a:r>
                      <a:r>
                        <a:rPr lang="nl-NL" sz="1100" i="1" u="none" strike="noStrike" dirty="0">
                          <a:effectLst/>
                        </a:rPr>
                        <a:t>.</a:t>
                      </a:r>
                      <a:r>
                        <a:rPr lang="nl-NL" sz="1100" u="none" strike="noStrike" dirty="0">
                          <a:effectLst/>
                        </a:rPr>
                        <a:t>(OTU18)</a:t>
                      </a:r>
                      <a:endParaRPr lang="nl-NL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664641"/>
                  </a:ext>
                </a:extLst>
              </a:tr>
              <a:tr h="205197">
                <a:tc>
                  <a:txBody>
                    <a:bodyPr/>
                    <a:lstStyle/>
                    <a:p>
                      <a:pPr algn="l" fontAlgn="b"/>
                      <a:r>
                        <a:rPr lang="nl-NL" sz="1100" i="1" u="none" strike="noStrike" dirty="0" err="1">
                          <a:effectLst/>
                        </a:rPr>
                        <a:t>Wickerhamomyces</a:t>
                      </a:r>
                      <a:r>
                        <a:rPr lang="nl-NL" sz="1100" i="1" u="none" strike="noStrike" dirty="0">
                          <a:effectLst/>
                        </a:rPr>
                        <a:t> </a:t>
                      </a:r>
                      <a:r>
                        <a:rPr lang="nl-NL" sz="1100" i="0" u="none" strike="noStrike" dirty="0" err="1">
                          <a:effectLst/>
                        </a:rPr>
                        <a:t>sp</a:t>
                      </a:r>
                      <a:r>
                        <a:rPr lang="nl-NL" sz="1100" i="0" u="none" strike="noStrike" dirty="0">
                          <a:effectLst/>
                        </a:rPr>
                        <a:t>. </a:t>
                      </a:r>
                      <a:r>
                        <a:rPr lang="nl-NL" sz="1100" u="none" strike="noStrike" dirty="0">
                          <a:effectLst/>
                        </a:rPr>
                        <a:t>(OTU35)</a:t>
                      </a:r>
                      <a:endParaRPr lang="nl-NL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42008117"/>
                  </a:ext>
                </a:extLst>
              </a:tr>
              <a:tr h="205197">
                <a:tc>
                  <a:txBody>
                    <a:bodyPr/>
                    <a:lstStyle/>
                    <a:p>
                      <a:pPr algn="l" fontAlgn="b"/>
                      <a:r>
                        <a:rPr lang="nl-NL" sz="1100" i="1" u="none" strike="noStrike" dirty="0">
                          <a:effectLst/>
                        </a:rPr>
                        <a:t>Hypocrea </a:t>
                      </a:r>
                      <a:r>
                        <a:rPr lang="nl-NL" sz="1100" i="0" u="none" strike="noStrike" dirty="0" err="1">
                          <a:effectLst/>
                        </a:rPr>
                        <a:t>sp</a:t>
                      </a:r>
                      <a:r>
                        <a:rPr lang="nl-NL" sz="1100" i="1" u="none" strike="noStrike" dirty="0">
                          <a:effectLst/>
                        </a:rPr>
                        <a:t>.</a:t>
                      </a:r>
                      <a:r>
                        <a:rPr lang="nl-NL" sz="1100" u="none" strike="noStrike" dirty="0">
                          <a:effectLst/>
                        </a:rPr>
                        <a:t>(OTU120)</a:t>
                      </a:r>
                      <a:endParaRPr lang="nl-NL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78584956"/>
                  </a:ext>
                </a:extLst>
              </a:tr>
            </a:tbl>
          </a:graphicData>
        </a:graphic>
      </p:graphicFrame>
      <p:sp>
        <p:nvSpPr>
          <p:cNvPr id="2" name="Tekstvak 1">
            <a:extLst>
              <a:ext uri="{FF2B5EF4-FFF2-40B4-BE49-F238E27FC236}">
                <a16:creationId xmlns:a16="http://schemas.microsoft.com/office/drawing/2014/main" id="{0C362AF7-EC72-4162-8F19-DF824AB3A491}"/>
              </a:ext>
            </a:extLst>
          </p:cNvPr>
          <p:cNvSpPr txBox="1"/>
          <p:nvPr/>
        </p:nvSpPr>
        <p:spPr>
          <a:xfrm rot="16200000">
            <a:off x="-195747" y="1711064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ample</a:t>
            </a:r>
            <a:endParaRPr lang="nl-NL" sz="1200" dirty="0"/>
          </a:p>
        </p:txBody>
      </p:sp>
      <p:sp>
        <p:nvSpPr>
          <p:cNvPr id="10" name="Tekstvak 9">
            <a:extLst>
              <a:ext uri="{FF2B5EF4-FFF2-40B4-BE49-F238E27FC236}">
                <a16:creationId xmlns:a16="http://schemas.microsoft.com/office/drawing/2014/main" id="{96CC66C5-2E5F-41DB-AC9C-D3BC5FE33663}"/>
              </a:ext>
            </a:extLst>
          </p:cNvPr>
          <p:cNvSpPr txBox="1"/>
          <p:nvPr/>
        </p:nvSpPr>
        <p:spPr>
          <a:xfrm rot="16200000">
            <a:off x="-207879" y="4824878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ample</a:t>
            </a:r>
            <a:endParaRPr lang="nl-NL" sz="1200" dirty="0"/>
          </a:p>
        </p:txBody>
      </p:sp>
      <p:sp>
        <p:nvSpPr>
          <p:cNvPr id="11" name="Tekstvak 10">
            <a:extLst>
              <a:ext uri="{FF2B5EF4-FFF2-40B4-BE49-F238E27FC236}">
                <a16:creationId xmlns:a16="http://schemas.microsoft.com/office/drawing/2014/main" id="{5CEDBEA1-F1BD-44AD-9FEF-46326FEF27F3}"/>
              </a:ext>
            </a:extLst>
          </p:cNvPr>
          <p:cNvSpPr txBox="1"/>
          <p:nvPr/>
        </p:nvSpPr>
        <p:spPr>
          <a:xfrm rot="16200000">
            <a:off x="5773636" y="1000822"/>
            <a:ext cx="6447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ample</a:t>
            </a:r>
            <a:endParaRPr lang="nl-NL" sz="1200" dirty="0"/>
          </a:p>
        </p:txBody>
      </p:sp>
      <p:sp>
        <p:nvSpPr>
          <p:cNvPr id="7" name="Tekstvak 6">
            <a:extLst>
              <a:ext uri="{FF2B5EF4-FFF2-40B4-BE49-F238E27FC236}">
                <a16:creationId xmlns:a16="http://schemas.microsoft.com/office/drawing/2014/main" id="{660542A0-B419-4214-9EE2-98A2633C45EF}"/>
              </a:ext>
            </a:extLst>
          </p:cNvPr>
          <p:cNvSpPr txBox="1"/>
          <p:nvPr/>
        </p:nvSpPr>
        <p:spPr>
          <a:xfrm>
            <a:off x="8072743" y="1798708"/>
            <a:ext cx="35799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Relative abundance (%)</a:t>
            </a:r>
            <a:endParaRPr lang="nl-NL" sz="1100" dirty="0"/>
          </a:p>
        </p:txBody>
      </p:sp>
      <p:sp>
        <p:nvSpPr>
          <p:cNvPr id="12" name="Tekstvak 11">
            <a:extLst>
              <a:ext uri="{FF2B5EF4-FFF2-40B4-BE49-F238E27FC236}">
                <a16:creationId xmlns:a16="http://schemas.microsoft.com/office/drawing/2014/main" id="{40F8FF32-E413-42CD-9A83-73FA3E8BFB46}"/>
              </a:ext>
            </a:extLst>
          </p:cNvPr>
          <p:cNvSpPr txBox="1"/>
          <p:nvPr/>
        </p:nvSpPr>
        <p:spPr>
          <a:xfrm>
            <a:off x="2221158" y="6650761"/>
            <a:ext cx="35799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Relative abundance (%)</a:t>
            </a:r>
            <a:endParaRPr lang="nl-NL" sz="1100" dirty="0"/>
          </a:p>
        </p:txBody>
      </p:sp>
    </p:spTree>
    <p:extLst>
      <p:ext uri="{BB962C8B-B14F-4D97-AF65-F5344CB8AC3E}">
        <p14:creationId xmlns:p14="http://schemas.microsoft.com/office/powerpoint/2010/main" val="1060237497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80</Words>
  <Application>Microsoft Office PowerPoint</Application>
  <PresentationFormat>Breedbeeld</PresentationFormat>
  <Paragraphs>19</Paragraphs>
  <Slides>1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3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Kantoorthema</vt:lpstr>
      <vt:lpstr>PowerPoint-presentati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Lien Bosmans</dc:creator>
  <cp:lastModifiedBy>Lien Bosmans</cp:lastModifiedBy>
  <cp:revision>9</cp:revision>
  <dcterms:created xsi:type="dcterms:W3CDTF">2018-08-20T17:35:14Z</dcterms:created>
  <dcterms:modified xsi:type="dcterms:W3CDTF">2018-08-30T19:53:30Z</dcterms:modified>
</cp:coreProperties>
</file>